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84" r:id="rId2"/>
  </p:sldIdLst>
  <p:sldSz cx="16916400" cy="2194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26" d="100"/>
          <a:sy n="26" d="100"/>
        </p:scale>
        <p:origin x="265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2EB3E9-7FC1-4091-982A-3ED580D49C5A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143000"/>
            <a:ext cx="2378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D2B3F1-9DE9-4B62-87EA-66A776D0C7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605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1pPr>
    <a:lvl2pPr marL="563179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2pPr>
    <a:lvl3pPr marL="1126358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3pPr>
    <a:lvl4pPr marL="1689537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4pPr>
    <a:lvl5pPr marL="2252716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5pPr>
    <a:lvl6pPr marL="2815895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6pPr>
    <a:lvl7pPr marL="3379074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7pPr>
    <a:lvl8pPr marL="3942253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8pPr>
    <a:lvl9pPr marL="4505432" algn="l" defTabSz="1126358" rtl="0" eaLnBrk="1" latinLnBrk="0" hangingPunct="1">
      <a:defRPr sz="147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68730" y="3591562"/>
            <a:ext cx="14378940" cy="7640320"/>
          </a:xfrm>
        </p:spPr>
        <p:txBody>
          <a:bodyPr anchor="b"/>
          <a:lstStyle>
            <a:lvl1pPr algn="ctr"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14550" y="11526522"/>
            <a:ext cx="12687300" cy="5298438"/>
          </a:xfrm>
        </p:spPr>
        <p:txBody>
          <a:bodyPr/>
          <a:lstStyle>
            <a:lvl1pPr marL="0" indent="0" algn="ctr">
              <a:buNone/>
              <a:defRPr sz="4440"/>
            </a:lvl1pPr>
            <a:lvl2pPr marL="845820" indent="0" algn="ctr">
              <a:buNone/>
              <a:defRPr sz="3700"/>
            </a:lvl2pPr>
            <a:lvl3pPr marL="1691640" indent="0" algn="ctr">
              <a:buNone/>
              <a:defRPr sz="3330"/>
            </a:lvl3pPr>
            <a:lvl4pPr marL="2537460" indent="0" algn="ctr">
              <a:buNone/>
              <a:defRPr sz="2960"/>
            </a:lvl4pPr>
            <a:lvl5pPr marL="3383280" indent="0" algn="ctr">
              <a:buNone/>
              <a:defRPr sz="2960"/>
            </a:lvl5pPr>
            <a:lvl6pPr marL="4229100" indent="0" algn="ctr">
              <a:buNone/>
              <a:defRPr sz="2960"/>
            </a:lvl6pPr>
            <a:lvl7pPr marL="5074920" indent="0" algn="ctr">
              <a:buNone/>
              <a:defRPr sz="2960"/>
            </a:lvl7pPr>
            <a:lvl8pPr marL="5920740" indent="0" algn="ctr">
              <a:buNone/>
              <a:defRPr sz="2960"/>
            </a:lvl8pPr>
            <a:lvl9pPr marL="6766560" indent="0" algn="ctr">
              <a:buNone/>
              <a:defRPr sz="2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464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626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105800" y="1168400"/>
            <a:ext cx="3647599" cy="1859788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63004" y="1168400"/>
            <a:ext cx="10731341" cy="1859788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7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658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193" y="5471167"/>
            <a:ext cx="14590395" cy="9128758"/>
          </a:xfrm>
        </p:spPr>
        <p:txBody>
          <a:bodyPr anchor="b"/>
          <a:lstStyle>
            <a:lvl1pPr>
              <a:defRPr sz="11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193" y="14686287"/>
            <a:ext cx="14590395" cy="4800598"/>
          </a:xfrm>
        </p:spPr>
        <p:txBody>
          <a:bodyPr/>
          <a:lstStyle>
            <a:lvl1pPr marL="0" indent="0">
              <a:buNone/>
              <a:defRPr sz="4440">
                <a:solidFill>
                  <a:schemeClr val="tx1">
                    <a:tint val="82000"/>
                  </a:schemeClr>
                </a:solidFill>
              </a:defRPr>
            </a:lvl1pPr>
            <a:lvl2pPr marL="845820" indent="0">
              <a:buNone/>
              <a:defRPr sz="3700">
                <a:solidFill>
                  <a:schemeClr val="tx1">
                    <a:tint val="82000"/>
                  </a:schemeClr>
                </a:solidFill>
              </a:defRPr>
            </a:lvl2pPr>
            <a:lvl3pPr marL="1691640" indent="0">
              <a:buNone/>
              <a:defRPr sz="3330">
                <a:solidFill>
                  <a:schemeClr val="tx1">
                    <a:tint val="82000"/>
                  </a:schemeClr>
                </a:solidFill>
              </a:defRPr>
            </a:lvl3pPr>
            <a:lvl4pPr marL="25374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4pPr>
            <a:lvl5pPr marL="338328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5pPr>
            <a:lvl6pPr marL="422910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6pPr>
            <a:lvl7pPr marL="507492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7pPr>
            <a:lvl8pPr marL="592074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8pPr>
            <a:lvl9pPr marL="6766560" indent="0">
              <a:buNone/>
              <a:defRPr sz="29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913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63003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63928" y="5842000"/>
            <a:ext cx="7189470" cy="1392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628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168405"/>
            <a:ext cx="14590395" cy="42418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5208" y="5379722"/>
            <a:ext cx="7156429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5208" y="8016240"/>
            <a:ext cx="7156429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563929" y="5379722"/>
            <a:ext cx="7191673" cy="2636518"/>
          </a:xfrm>
        </p:spPr>
        <p:txBody>
          <a:bodyPr anchor="b"/>
          <a:lstStyle>
            <a:lvl1pPr marL="0" indent="0">
              <a:buNone/>
              <a:defRPr sz="4440" b="1"/>
            </a:lvl1pPr>
            <a:lvl2pPr marL="845820" indent="0">
              <a:buNone/>
              <a:defRPr sz="3700" b="1"/>
            </a:lvl2pPr>
            <a:lvl3pPr marL="1691640" indent="0">
              <a:buNone/>
              <a:defRPr sz="3330" b="1"/>
            </a:lvl3pPr>
            <a:lvl4pPr marL="2537460" indent="0">
              <a:buNone/>
              <a:defRPr sz="2960" b="1"/>
            </a:lvl4pPr>
            <a:lvl5pPr marL="3383280" indent="0">
              <a:buNone/>
              <a:defRPr sz="2960" b="1"/>
            </a:lvl5pPr>
            <a:lvl6pPr marL="4229100" indent="0">
              <a:buNone/>
              <a:defRPr sz="2960" b="1"/>
            </a:lvl6pPr>
            <a:lvl7pPr marL="5074920" indent="0">
              <a:buNone/>
              <a:defRPr sz="2960" b="1"/>
            </a:lvl7pPr>
            <a:lvl8pPr marL="5920740" indent="0">
              <a:buNone/>
              <a:defRPr sz="2960" b="1"/>
            </a:lvl8pPr>
            <a:lvl9pPr marL="6766560" indent="0">
              <a:buNone/>
              <a:defRPr sz="2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563929" y="8016240"/>
            <a:ext cx="7191673" cy="117906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12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33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907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1673" y="3159765"/>
            <a:ext cx="8563928" cy="15595600"/>
          </a:xfrm>
        </p:spPr>
        <p:txBody>
          <a:bodyPr/>
          <a:lstStyle>
            <a:lvl1pPr>
              <a:defRPr sz="5920"/>
            </a:lvl1pPr>
            <a:lvl2pPr>
              <a:defRPr sz="5180"/>
            </a:lvl2pPr>
            <a:lvl3pPr>
              <a:defRPr sz="4440"/>
            </a:lvl3pPr>
            <a:lvl4pPr>
              <a:defRPr sz="3700"/>
            </a:lvl4pPr>
            <a:lvl5pPr>
              <a:defRPr sz="3700"/>
            </a:lvl5pPr>
            <a:lvl6pPr>
              <a:defRPr sz="3700"/>
            </a:lvl6pPr>
            <a:lvl7pPr>
              <a:defRPr sz="3700"/>
            </a:lvl7pPr>
            <a:lvl8pPr>
              <a:defRPr sz="3700"/>
            </a:lvl8pPr>
            <a:lvl9pPr>
              <a:defRPr sz="3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2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5206" y="1463040"/>
            <a:ext cx="5455979" cy="5120640"/>
          </a:xfrm>
        </p:spPr>
        <p:txBody>
          <a:bodyPr anchor="b"/>
          <a:lstStyle>
            <a:lvl1pPr>
              <a:defRPr sz="5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191673" y="3159765"/>
            <a:ext cx="8563928" cy="15595600"/>
          </a:xfrm>
        </p:spPr>
        <p:txBody>
          <a:bodyPr anchor="t"/>
          <a:lstStyle>
            <a:lvl1pPr marL="0" indent="0">
              <a:buNone/>
              <a:defRPr sz="5920"/>
            </a:lvl1pPr>
            <a:lvl2pPr marL="845820" indent="0">
              <a:buNone/>
              <a:defRPr sz="5180"/>
            </a:lvl2pPr>
            <a:lvl3pPr marL="1691640" indent="0">
              <a:buNone/>
              <a:defRPr sz="4440"/>
            </a:lvl3pPr>
            <a:lvl4pPr marL="2537460" indent="0">
              <a:buNone/>
              <a:defRPr sz="3700"/>
            </a:lvl4pPr>
            <a:lvl5pPr marL="3383280" indent="0">
              <a:buNone/>
              <a:defRPr sz="3700"/>
            </a:lvl5pPr>
            <a:lvl6pPr marL="4229100" indent="0">
              <a:buNone/>
              <a:defRPr sz="3700"/>
            </a:lvl6pPr>
            <a:lvl7pPr marL="5074920" indent="0">
              <a:buNone/>
              <a:defRPr sz="3700"/>
            </a:lvl7pPr>
            <a:lvl8pPr marL="5920740" indent="0">
              <a:buNone/>
              <a:defRPr sz="3700"/>
            </a:lvl8pPr>
            <a:lvl9pPr marL="6766560" indent="0">
              <a:buNone/>
              <a:defRPr sz="3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5206" y="6583680"/>
            <a:ext cx="5455979" cy="12197082"/>
          </a:xfrm>
        </p:spPr>
        <p:txBody>
          <a:bodyPr/>
          <a:lstStyle>
            <a:lvl1pPr marL="0" indent="0">
              <a:buNone/>
              <a:defRPr sz="2960"/>
            </a:lvl1pPr>
            <a:lvl2pPr marL="845820" indent="0">
              <a:buNone/>
              <a:defRPr sz="2590"/>
            </a:lvl2pPr>
            <a:lvl3pPr marL="1691640" indent="0">
              <a:buNone/>
              <a:defRPr sz="2220"/>
            </a:lvl3pPr>
            <a:lvl4pPr marL="2537460" indent="0">
              <a:buNone/>
              <a:defRPr sz="1850"/>
            </a:lvl4pPr>
            <a:lvl5pPr marL="3383280" indent="0">
              <a:buNone/>
              <a:defRPr sz="1850"/>
            </a:lvl5pPr>
            <a:lvl6pPr marL="4229100" indent="0">
              <a:buNone/>
              <a:defRPr sz="1850"/>
            </a:lvl6pPr>
            <a:lvl7pPr marL="5074920" indent="0">
              <a:buNone/>
              <a:defRPr sz="1850"/>
            </a:lvl7pPr>
            <a:lvl8pPr marL="5920740" indent="0">
              <a:buNone/>
              <a:defRPr sz="1850"/>
            </a:lvl8pPr>
            <a:lvl9pPr marL="6766560" indent="0">
              <a:buNone/>
              <a:defRPr sz="1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34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63003" y="1168405"/>
            <a:ext cx="14590395" cy="4241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63003" y="5842000"/>
            <a:ext cx="14590395" cy="1392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63003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19854B-12D3-488A-93C0-B09B112B354E}" type="datetimeFigureOut">
              <a:rPr lang="en-US" smtClean="0"/>
              <a:t>5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03558" y="20340325"/>
            <a:ext cx="5709285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947208" y="20340325"/>
            <a:ext cx="3806190" cy="1168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C9F57E-B418-4AB9-A32D-9675841616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59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91640" rtl="0" eaLnBrk="1" latinLnBrk="0" hangingPunct="1">
        <a:lnSpc>
          <a:spcPct val="90000"/>
        </a:lnSpc>
        <a:spcBef>
          <a:spcPct val="0"/>
        </a:spcBef>
        <a:buNone/>
        <a:defRPr sz="81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2910" indent="-422910" algn="l" defTabSz="1691640" rtl="0" eaLnBrk="1" latinLnBrk="0" hangingPunct="1">
        <a:lnSpc>
          <a:spcPct val="90000"/>
        </a:lnSpc>
        <a:spcBef>
          <a:spcPts val="1850"/>
        </a:spcBef>
        <a:buFont typeface="Arial" panose="020B0604020202020204" pitchFamily="34" charset="0"/>
        <a:buChar char="•"/>
        <a:defRPr sz="5180" kern="1200">
          <a:solidFill>
            <a:schemeClr val="tx1"/>
          </a:solidFill>
          <a:latin typeface="+mn-lt"/>
          <a:ea typeface="+mn-ea"/>
          <a:cs typeface="+mn-cs"/>
        </a:defRPr>
      </a:lvl1pPr>
      <a:lvl2pPr marL="12687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4440" kern="1200">
          <a:solidFill>
            <a:schemeClr val="tx1"/>
          </a:solidFill>
          <a:latin typeface="+mn-lt"/>
          <a:ea typeface="+mn-ea"/>
          <a:cs typeface="+mn-cs"/>
        </a:defRPr>
      </a:lvl2pPr>
      <a:lvl3pPr marL="21145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9603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80619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65201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49783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634365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7189470" indent="-422910" algn="l" defTabSz="1691640" rtl="0" eaLnBrk="1" latinLnBrk="0" hangingPunct="1">
        <a:lnSpc>
          <a:spcPct val="90000"/>
        </a:lnSpc>
        <a:spcBef>
          <a:spcPts val="925"/>
        </a:spcBef>
        <a:buFont typeface="Arial" panose="020B0604020202020204" pitchFamily="34" charset="0"/>
        <a:buChar char="•"/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1pPr>
      <a:lvl2pPr marL="8458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2pPr>
      <a:lvl3pPr marL="16916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3pPr>
      <a:lvl4pPr marL="25374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4pPr>
      <a:lvl5pPr marL="338328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5pPr>
      <a:lvl6pPr marL="422910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6pPr>
      <a:lvl7pPr marL="507492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7pPr>
      <a:lvl8pPr marL="592074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8pPr>
      <a:lvl9pPr marL="6766560" algn="l" defTabSz="1691640" rtl="0" eaLnBrk="1" latinLnBrk="0" hangingPunct="1">
        <a:defRPr sz="33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E459E6F-35DA-F00C-6EA6-9E1562ADC42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B8DF2837-D2EF-C5B8-FD07-A22BC9A7FFF1}"/>
              </a:ext>
            </a:extLst>
          </p:cNvPr>
          <p:cNvSpPr txBox="1">
            <a:spLocks/>
          </p:cNvSpPr>
          <p:nvPr/>
        </p:nvSpPr>
        <p:spPr>
          <a:xfrm>
            <a:off x="1031357" y="1433442"/>
            <a:ext cx="9011002" cy="952499"/>
          </a:xfrm>
          <a:prstGeom prst="rect">
            <a:avLst/>
          </a:prstGeom>
        </p:spPr>
        <p:txBody>
          <a:bodyPr/>
          <a:lstStyle>
            <a:lvl1pPr algn="l" defTabSz="16916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81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200" b="1" dirty="0"/>
              <a:t>S4 Table</a:t>
            </a:r>
            <a:r>
              <a:rPr lang="en-US" sz="3200" dirty="0"/>
              <a:t>. Reciprocal gene drive model fit compariso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00BF2A2-9B20-D00A-DBF8-AD23B4E4C1F1}"/>
              </a:ext>
            </a:extLst>
          </p:cNvPr>
          <p:cNvSpPr txBox="1"/>
          <p:nvPr/>
        </p:nvSpPr>
        <p:spPr>
          <a:xfrm>
            <a:off x="1031356" y="9509035"/>
            <a:ext cx="901100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The GD model parameters were scored by the mean absolute scaled error values (MASE). The models and parameters, which best fit to either the </a:t>
            </a:r>
            <a:r>
              <a:rPr lang="en-US" sz="2400" i="1" dirty="0"/>
              <a:t>nanos-</a:t>
            </a:r>
            <a:r>
              <a:rPr lang="en-US" sz="2400" dirty="0"/>
              <a:t>GD</a:t>
            </a:r>
            <a:r>
              <a:rPr lang="en-US" sz="2400" i="1" dirty="0"/>
              <a:t> or</a:t>
            </a:r>
            <a:r>
              <a:rPr lang="en-US" sz="2400" dirty="0"/>
              <a:t> </a:t>
            </a:r>
            <a:r>
              <a:rPr lang="en-US" sz="2400" i="1" dirty="0" err="1"/>
              <a:t>zpg</a:t>
            </a:r>
            <a:r>
              <a:rPr lang="en-US" sz="2400" dirty="0"/>
              <a:t>-GD dynamics observed in the cage trials for the reciprocal test are indicated in </a:t>
            </a:r>
            <a:r>
              <a:rPr lang="en-US" sz="2400" b="1" dirty="0"/>
              <a:t>bold</a:t>
            </a:r>
            <a:r>
              <a:rPr lang="en-US" sz="2400" dirty="0"/>
              <a:t>.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DEE6344-9719-BEC4-EB2A-4E3941C9E2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5861616"/>
              </p:ext>
            </p:extLst>
          </p:nvPr>
        </p:nvGraphicFramePr>
        <p:xfrm>
          <a:off x="1137958" y="2385941"/>
          <a:ext cx="8462643" cy="695525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31488">
                  <a:extLst>
                    <a:ext uri="{9D8B030D-6E8A-4147-A177-3AD203B41FA5}">
                      <a16:colId xmlns:a16="http://schemas.microsoft.com/office/drawing/2014/main" val="2008977211"/>
                    </a:ext>
                  </a:extLst>
                </a:gridCol>
                <a:gridCol w="1364237">
                  <a:extLst>
                    <a:ext uri="{9D8B030D-6E8A-4147-A177-3AD203B41FA5}">
                      <a16:colId xmlns:a16="http://schemas.microsoft.com/office/drawing/2014/main" val="541979037"/>
                    </a:ext>
                  </a:extLst>
                </a:gridCol>
                <a:gridCol w="1294674">
                  <a:extLst>
                    <a:ext uri="{9D8B030D-6E8A-4147-A177-3AD203B41FA5}">
                      <a16:colId xmlns:a16="http://schemas.microsoft.com/office/drawing/2014/main" val="1625134865"/>
                    </a:ext>
                  </a:extLst>
                </a:gridCol>
                <a:gridCol w="1537232">
                  <a:extLst>
                    <a:ext uri="{9D8B030D-6E8A-4147-A177-3AD203B41FA5}">
                      <a16:colId xmlns:a16="http://schemas.microsoft.com/office/drawing/2014/main" val="720565942"/>
                    </a:ext>
                  </a:extLst>
                </a:gridCol>
                <a:gridCol w="1267506">
                  <a:extLst>
                    <a:ext uri="{9D8B030D-6E8A-4147-A177-3AD203B41FA5}">
                      <a16:colId xmlns:a16="http://schemas.microsoft.com/office/drawing/2014/main" val="1335780108"/>
                    </a:ext>
                  </a:extLst>
                </a:gridCol>
                <a:gridCol w="1267506">
                  <a:extLst>
                    <a:ext uri="{9D8B030D-6E8A-4147-A177-3AD203B41FA5}">
                      <a16:colId xmlns:a16="http://schemas.microsoft.com/office/drawing/2014/main" val="4241918651"/>
                    </a:ext>
                  </a:extLst>
                </a:gridCol>
              </a:tblGrid>
              <a:tr h="474124">
                <a:tc gridSpan="3">
                  <a:txBody>
                    <a:bodyPr/>
                    <a:lstStyle/>
                    <a:p>
                      <a:r>
                        <a:rPr lang="en-US" sz="2000" i="1" dirty="0" err="1">
                          <a:solidFill>
                            <a:sysClr val="windowText" lastClr="000000"/>
                          </a:solidFill>
                        </a:rPr>
                        <a:t>zpg</a:t>
                      </a:r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-GD fit to models with </a:t>
                      </a:r>
                      <a:r>
                        <a:rPr lang="en-US" sz="2000" i="1" dirty="0">
                          <a:solidFill>
                            <a:sysClr val="windowText" lastClr="000000"/>
                          </a:solidFill>
                        </a:rPr>
                        <a:t>nanos</a:t>
                      </a:r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- parameter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20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r>
                        <a:rPr lang="en-US" sz="2000" i="1" dirty="0">
                          <a:solidFill>
                            <a:sysClr val="windowText" lastClr="000000"/>
                          </a:solidFill>
                        </a:rPr>
                        <a:t>nanos</a:t>
                      </a:r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-GD fit to models with </a:t>
                      </a:r>
                      <a:r>
                        <a:rPr lang="en-US" sz="2000" i="1" dirty="0" err="1">
                          <a:solidFill>
                            <a:sysClr val="windowText" lastClr="000000"/>
                          </a:solidFill>
                        </a:rPr>
                        <a:t>zpg</a:t>
                      </a:r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- parameter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5371471"/>
                  </a:ext>
                </a:extLst>
              </a:tr>
              <a:tr h="790206"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MASE (GD invasio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MASE (RA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MASE (GD invasion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MASE (RA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2280807"/>
                  </a:ext>
                </a:extLst>
              </a:tr>
              <a:tr h="474124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anosM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4.21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84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zpgM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57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5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9923472"/>
                  </a:ext>
                </a:extLst>
              </a:tr>
              <a:tr h="474124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anosM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3.5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18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zpgM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6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49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9511179"/>
                  </a:ext>
                </a:extLst>
              </a:tr>
              <a:tr h="474124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anosM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43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33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zpgM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1.7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1.03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7444694"/>
                  </a:ext>
                </a:extLst>
              </a:tr>
              <a:tr h="474124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anosM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07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4.66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zpgM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74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3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4032114"/>
                  </a:ext>
                </a:extLst>
              </a:tr>
              <a:tr h="484656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anosM3s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6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17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zpgM3s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56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83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6376896"/>
                  </a:ext>
                </a:extLst>
              </a:tr>
              <a:tr h="450317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anosM3s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31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4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zpgM3s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1.59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1.5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9093971"/>
                  </a:ext>
                </a:extLst>
              </a:tr>
              <a:tr h="505472"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nanosM3s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01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2.67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zpgM3s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67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solidFill>
                            <a:sysClr val="windowText" lastClr="000000"/>
                          </a:solidFill>
                        </a:rPr>
                        <a:t>1.23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110109"/>
                  </a:ext>
                </a:extLst>
              </a:tr>
              <a:tr h="505359"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nanosM3s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1.71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2.90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2179442"/>
                  </a:ext>
                </a:extLst>
              </a:tr>
              <a:tr h="461415"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nanosM4s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1.8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1" dirty="0">
                          <a:solidFill>
                            <a:sysClr val="windowText" lastClr="000000"/>
                          </a:solidFill>
                        </a:rPr>
                        <a:t>2.2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7036640"/>
                  </a:ext>
                </a:extLst>
              </a:tr>
              <a:tr h="472401"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nanosM4s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1.86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3.47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9399173"/>
                  </a:ext>
                </a:extLst>
              </a:tr>
              <a:tr h="472257"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nanosM4s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1.09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2000" b="0" dirty="0">
                          <a:solidFill>
                            <a:sysClr val="windowText" lastClr="000000"/>
                          </a:solidFill>
                        </a:rPr>
                        <a:t>3.58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2000" b="1" dirty="0">
                        <a:solidFill>
                          <a:sysClr val="windowText" lastClr="000000"/>
                        </a:solidFill>
                        <a:highlight>
                          <a:srgbClr val="C0C0C0"/>
                        </a:highlight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24645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54073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61</TotalTime>
  <Words>142</Words>
  <Application>Microsoft Office PowerPoint</Application>
  <PresentationFormat>Custom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ach Speth</dc:creator>
  <cp:lastModifiedBy>Franz, Alexander</cp:lastModifiedBy>
  <cp:revision>432</cp:revision>
  <dcterms:created xsi:type="dcterms:W3CDTF">2024-06-26T16:03:17Z</dcterms:created>
  <dcterms:modified xsi:type="dcterms:W3CDTF">2025-05-09T15:18:49Z</dcterms:modified>
</cp:coreProperties>
</file>